
<file path=[Content_Types].xml><?xml version="1.0" encoding="utf-8"?>
<Types xmlns="http://schemas.openxmlformats.org/package/2006/content-types">
  <Override PartName="/docProps/core.xml" ContentType="application/vnd.openxmlformats-package.core-properties+xml"/>
  <Default Extension="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Default Extension="png" ContentType="image/png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60" r:id="rId1"/>
  </p:sldMasterIdLst>
  <p:sldIdLst>
    <p:sldId id="256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:p="http://schemas.openxmlformats.org/presentationml/2006/main" xmlns:r="http://schemas.openxmlformats.org/officeDocument/2006/relationships" xmlns:a="http://schemas.openxmlformats.org/drawingml/2006/main" xmlns="">
        <p15:guide id="2" pos="4156" userDrawn="1">
          <p15:clr>
            <a:srgbClr val="A4A3A4"/>
          </p15:clr>
        </p15:guide>
        <p15:guide id="3" orient="horz" pos="127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extLst>
    <p:ext uri="{E76CE94A-603C-4142-B9EB-6D1370010A27}">
      <p14:discardImageEditData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0"/>
    </p:ext>
    <p:ext uri="{D31A062A-798A-4329-ABDD-BBA856620510}">
      <p14:defaultImageDpi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2767"/>
    </p:ext>
    <p:ext uri="{FD5EFAAD-0ECE-453E-9831-46B23BE46B34}">
      <p15:chartTrackingRefBased xmlns:p15="http://schemas.microsoft.com/office/powerpoint/2012/main" xmlns:p="http://schemas.openxmlformats.org/presentationml/2006/main" xmlns:r="http://schemas.openxmlformats.org/officeDocument/2006/relationships" xmlns:a="http://schemas.openxmlformats.org/drawingml/2006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 horzBarState="maximized">
    <p:restoredLeft sz="15614"/>
    <p:restoredTop sz="94674"/>
  </p:normalViewPr>
  <p:slideViewPr>
    <p:cSldViewPr snapToGrid="0" snapToObjects="1" showGuides="1">
      <p:cViewPr varScale="1">
        <p:scale>
          <a:sx n="60" d="100"/>
          <a:sy n="60" d="100"/>
        </p:scale>
        <p:origin x="-2064" y="-96"/>
      </p:cViewPr>
      <p:guideLst>
        <p:guide orient="horz" pos="1270"/>
        <p:guide pos="415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8209708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9464378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6133842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4294807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7750442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5244153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1991612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5670867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5026182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4789972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1444508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5569191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0" name="Grouper 109"/>
          <p:cNvGrpSpPr/>
          <p:nvPr/>
        </p:nvGrpSpPr>
        <p:grpSpPr>
          <a:xfrm>
            <a:off x="295960" y="686127"/>
            <a:ext cx="6114249" cy="5726130"/>
            <a:chOff x="295960" y="199286"/>
            <a:chExt cx="6114249" cy="5726130"/>
          </a:xfrm>
        </p:grpSpPr>
        <p:grpSp>
          <p:nvGrpSpPr>
            <p:cNvPr id="204" name="Groupe 203">
              <a:extLst>
                <a:ext uri="{FF2B5EF4-FFF2-40B4-BE49-F238E27FC236}">
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D1161430-A3E0-F046-9A45-874748F358BA}"/>
                </a:ext>
              </a:extLst>
            </p:cNvPr>
            <p:cNvGrpSpPr/>
            <p:nvPr/>
          </p:nvGrpSpPr>
          <p:grpSpPr>
            <a:xfrm>
              <a:off x="1797566" y="199286"/>
              <a:ext cx="2652925" cy="1772778"/>
              <a:chOff x="1797566" y="199286"/>
              <a:chExt cx="2652925" cy="1772778"/>
            </a:xfrm>
          </p:grpSpPr>
          <p:sp>
            <p:nvSpPr>
              <p:cNvPr id="85" name="ZoneTexte 84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83034674-1E29-B544-BA8B-0AD88BFB41B6}"/>
                  </a:ext>
                </a:extLst>
              </p:cNvPr>
              <p:cNvSpPr txBox="1"/>
              <p:nvPr/>
            </p:nvSpPr>
            <p:spPr>
              <a:xfrm>
                <a:off x="1797566" y="199286"/>
                <a:ext cx="33214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  <p:grpSp>
            <p:nvGrpSpPr>
              <p:cNvPr id="64" name="Groupe 63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50FE1D35-A6BB-F845-B00E-B26C29A31559}"/>
                  </a:ext>
                </a:extLst>
              </p:cNvPr>
              <p:cNvGrpSpPr/>
              <p:nvPr/>
            </p:nvGrpSpPr>
            <p:grpSpPr>
              <a:xfrm>
                <a:off x="2129708" y="333739"/>
                <a:ext cx="2320783" cy="1638325"/>
                <a:chOff x="2124773" y="262118"/>
                <a:chExt cx="2320783" cy="1638325"/>
              </a:xfrm>
            </p:grpSpPr>
            <p:grpSp>
              <p:nvGrpSpPr>
                <p:cNvPr id="62" name="Groupe 61">
                  <a:extLst>
                    <a:ext uri="{FF2B5EF4-FFF2-40B4-BE49-F238E27FC236}">
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398B455E-CA92-A24E-BAAF-ECB16C33A759}"/>
                    </a:ext>
                  </a:extLst>
                </p:cNvPr>
                <p:cNvGrpSpPr/>
                <p:nvPr/>
              </p:nvGrpSpPr>
              <p:grpSpPr>
                <a:xfrm>
                  <a:off x="2789457" y="262118"/>
                  <a:ext cx="667526" cy="559712"/>
                  <a:chOff x="2789457" y="262118"/>
                  <a:chExt cx="667526" cy="559712"/>
                </a:xfrm>
              </p:grpSpPr>
              <p:sp>
                <p:nvSpPr>
                  <p:cNvPr id="167" name="TextBox 119">
                    <a:extLst>
                      <a:ext uri="{FF2B5EF4-FFF2-40B4-BE49-F238E27FC236}">
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AF2E9F0A-C421-D04A-B2F1-878931DD7717}"/>
                      </a:ext>
                    </a:extLst>
                  </p:cNvPr>
                  <p:cNvSpPr txBox="1"/>
                  <p:nvPr/>
                </p:nvSpPr>
                <p:spPr>
                  <a:xfrm>
                    <a:off x="2789457" y="452498"/>
                    <a:ext cx="667526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IMLP</a:t>
                    </a:r>
                  </a:p>
                  <a:p>
                    <a:pPr algn="ctr"/>
                    <a:r>
                      <a: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_16720</a:t>
                    </a:r>
                  </a:p>
                </p:txBody>
              </p:sp>
              <p:sp>
                <p:nvSpPr>
                  <p:cNvPr id="168" name="TextBox 120">
                    <a:extLst>
                      <a:ext uri="{FF2B5EF4-FFF2-40B4-BE49-F238E27FC236}">
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8D83DB92-EAAC-DF4A-8949-56E576C555DE}"/>
                      </a:ext>
                    </a:extLst>
                  </p:cNvPr>
                  <p:cNvSpPr txBox="1"/>
                  <p:nvPr/>
                </p:nvSpPr>
                <p:spPr>
                  <a:xfrm>
                    <a:off x="2860598" y="262118"/>
                    <a:ext cx="530396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 fontAlgn="b"/>
                    <a:r>
                      <a:rPr lang="en-US" sz="1000" b="1" i="1" dirty="0" err="1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vicR</a:t>
                    </a:r>
                    <a:endParaRPr lang="en-US" sz="1000" b="1" i="1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61" name="Groupe 60">
                  <a:extLst>
                    <a:ext uri="{FF2B5EF4-FFF2-40B4-BE49-F238E27FC236}">
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C02462C8-28BA-EE48-8707-C349D5143EC8}"/>
                    </a:ext>
                  </a:extLst>
                </p:cNvPr>
                <p:cNvGrpSpPr/>
                <p:nvPr/>
              </p:nvGrpSpPr>
              <p:grpSpPr>
                <a:xfrm>
                  <a:off x="2357569" y="1031968"/>
                  <a:ext cx="2087987" cy="327444"/>
                  <a:chOff x="2357569" y="1031968"/>
                  <a:chExt cx="2087987" cy="327444"/>
                </a:xfrm>
              </p:grpSpPr>
              <p:grpSp>
                <p:nvGrpSpPr>
                  <p:cNvPr id="157" name="Grouper 262">
                    <a:extLst>
                      <a:ext uri="{FF2B5EF4-FFF2-40B4-BE49-F238E27FC236}">
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9554EC00-6BB0-7045-98F5-F118ABC4755A}"/>
                      </a:ext>
                    </a:extLst>
                  </p:cNvPr>
                  <p:cNvGrpSpPr/>
                  <p:nvPr/>
                </p:nvGrpSpPr>
                <p:grpSpPr>
                  <a:xfrm>
                    <a:off x="2357569" y="1071412"/>
                    <a:ext cx="2087987" cy="288000"/>
                    <a:chOff x="8336674" y="39913299"/>
                    <a:chExt cx="2087987" cy="288000"/>
                  </a:xfrm>
                </p:grpSpPr>
                <p:cxnSp>
                  <p:nvCxnSpPr>
                    <p:cNvPr id="158" name="Straight Connector 90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BA2E262D-9FEC-9D42-998A-E940AB311C4C}"/>
                        </a:ext>
                      </a:extLst>
                    </p:cNvPr>
                    <p:cNvCxnSpPr/>
                    <p:nvPr/>
                  </p:nvCxnSpPr>
                  <p:spPr>
                    <a:xfrm flipV="1">
                      <a:off x="8336674" y="40055735"/>
                      <a:ext cx="2087987" cy="3127"/>
                    </a:xfrm>
                    <a:prstGeom prst="line">
                      <a:avLst/>
                    </a:prstGeom>
                    <a:ln w="19050" cap="flat" cmpd="sng" algn="ctr">
                      <a:solidFill>
                        <a:schemeClr val="dk1"/>
                      </a:solidFill>
                      <a:prstDash val="solid"/>
                      <a:round/>
                      <a:headEnd type="none" w="med" len="med"/>
                      <a:tailEnd type="none" w="med" len="med"/>
                    </a:ln>
                  </p:spPr>
                  <p:style>
                    <a:lnRef idx="3">
                      <a:schemeClr val="dk1"/>
                    </a:lnRef>
                    <a:fillRef idx="0">
                      <a:schemeClr val="dk1"/>
                    </a:fillRef>
                    <a:effectRef idx="2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59" name="Down Arrow 85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2427FC21-26D3-0640-996B-62EB68E03D00}"/>
                        </a:ext>
                      </a:extLst>
                    </p:cNvPr>
                    <p:cNvSpPr>
                      <a:spLocks noChangeAspect="1"/>
                    </p:cNvSpPr>
                    <p:nvPr/>
                  </p:nvSpPr>
                  <p:spPr>
                    <a:xfrm rot="16200000">
                      <a:off x="9345557" y="39865151"/>
                      <a:ext cx="259273" cy="384294"/>
                    </a:xfrm>
                    <a:prstGeom prst="downArrow">
                      <a:avLst>
                        <a:gd name="adj1" fmla="val 56250"/>
                        <a:gd name="adj2" fmla="val 50000"/>
                      </a:avLst>
                    </a:prstGeom>
                    <a:solidFill>
                      <a:schemeClr val="tx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vert="vert270" rtlCol="0" anchor="ctr"/>
                    <a:lstStyle/>
                    <a:p>
                      <a:pPr algn="ctr"/>
                      <a:endParaRPr lang="en-US" sz="14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60" name="Down Arrow 85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77E370D8-FA75-0F4F-8558-10002D32FADF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>
                    <a:xfrm rot="16200000">
                      <a:off x="9017789" y="39895298"/>
                      <a:ext cx="259273" cy="324000"/>
                    </a:xfrm>
                    <a:prstGeom prst="downArrow">
                      <a:avLst>
                        <a:gd name="adj1" fmla="val 56250"/>
                        <a:gd name="adj2" fmla="val 50000"/>
                      </a:avLst>
                    </a:prstGeom>
                    <a:solidFill>
                      <a:schemeClr val="tx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vert="vert270" rtlCol="0" anchor="ctr"/>
                    <a:lstStyle/>
                    <a:p>
                      <a:pPr algn="ctr"/>
                      <a:endParaRPr lang="en-US" sz="14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61" name="Down Arrow 85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D866BF26-D6A4-DD4D-A3BE-0B70D9C1A2E0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>
                    <a:xfrm rot="16200000">
                      <a:off x="9925629" y="39859303"/>
                      <a:ext cx="287999" cy="395991"/>
                    </a:xfrm>
                    <a:prstGeom prst="downArrow">
                      <a:avLst>
                        <a:gd name="adj1" fmla="val 56250"/>
                        <a:gd name="adj2" fmla="val 50000"/>
                      </a:avLst>
                    </a:prstGeom>
                    <a:solidFill>
                      <a:schemeClr val="tx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vert="vert270" rtlCol="0" anchor="ctr"/>
                    <a:lstStyle/>
                    <a:p>
                      <a:pPr algn="ctr"/>
                      <a:endParaRPr lang="en-US" sz="14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62" name="Down Arrow 85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9306773A-5717-9143-B67E-E00947419D1C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>
                    <a:xfrm rot="16200000">
                      <a:off x="8333475" y="39967300"/>
                      <a:ext cx="288000" cy="179997"/>
                    </a:xfrm>
                    <a:prstGeom prst="downArrow">
                      <a:avLst>
                        <a:gd name="adj1" fmla="val 56250"/>
                        <a:gd name="adj2" fmla="val 50000"/>
                      </a:avLst>
                    </a:prstGeom>
                    <a:solidFill>
                      <a:schemeClr val="tx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vert="vert270" rtlCol="0" anchor="ctr"/>
                    <a:lstStyle/>
                    <a:p>
                      <a:pPr algn="ctr"/>
                      <a:endParaRPr lang="en-US" sz="14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169" name="TextBox 25">
                    <a:extLst>
                      <a:ext uri="{FF2B5EF4-FFF2-40B4-BE49-F238E27FC236}">
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9F93B7EA-DEE2-DA44-8935-99A759011FC1}"/>
                      </a:ext>
                    </a:extLst>
                  </p:cNvPr>
                  <p:cNvSpPr txBox="1"/>
                  <p:nvPr/>
                </p:nvSpPr>
                <p:spPr>
                  <a:xfrm>
                    <a:off x="2629229" y="1031968"/>
                    <a:ext cx="317722" cy="13849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309</a:t>
                    </a:r>
                  </a:p>
                </p:txBody>
              </p:sp>
              <p:sp>
                <p:nvSpPr>
                  <p:cNvPr id="170" name="TextBox 25">
                    <a:extLst>
                      <a:ext uri="{FF2B5EF4-FFF2-40B4-BE49-F238E27FC236}">
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AF0C44C9-C69B-A14A-B00C-9656230D693F}"/>
                      </a:ext>
                    </a:extLst>
                  </p:cNvPr>
                  <p:cNvSpPr txBox="1"/>
                  <p:nvPr/>
                </p:nvSpPr>
                <p:spPr>
                  <a:xfrm>
                    <a:off x="3670308" y="1043816"/>
                    <a:ext cx="219566" cy="13849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75</a:t>
                    </a:r>
                  </a:p>
                </p:txBody>
              </p:sp>
            </p:grpSp>
            <p:sp>
              <p:nvSpPr>
                <p:cNvPr id="171" name="TextBox 104">
                  <a:extLst>
                    <a:ext uri="{FF2B5EF4-FFF2-40B4-BE49-F238E27FC236}">
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DE4DDC28-A648-874D-8404-FF849B4D8992}"/>
                    </a:ext>
                  </a:extLst>
                </p:cNvPr>
                <p:cNvSpPr txBox="1"/>
                <p:nvPr/>
              </p:nvSpPr>
              <p:spPr>
                <a:xfrm>
                  <a:off x="2124773" y="735304"/>
                  <a:ext cx="642136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IMLP</a:t>
                  </a:r>
                </a:p>
                <a:p>
                  <a:pPr algn="ctr"/>
                  <a:r>
                    <a:rPr lang="en-US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_16715</a:t>
                  </a:r>
                </a:p>
              </p:txBody>
            </p:sp>
            <p:sp>
              <p:nvSpPr>
                <p:cNvPr id="172" name="TextBox 104">
                  <a:extLst>
                    <a:ext uri="{FF2B5EF4-FFF2-40B4-BE49-F238E27FC236}">
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C2C2B400-7726-D94E-B8E3-54ECCB3EFC24}"/>
                    </a:ext>
                  </a:extLst>
                </p:cNvPr>
                <p:cNvSpPr txBox="1"/>
                <p:nvPr/>
              </p:nvSpPr>
              <p:spPr>
                <a:xfrm>
                  <a:off x="3801954" y="735304"/>
                  <a:ext cx="598855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IMLP</a:t>
                  </a:r>
                </a:p>
                <a:p>
                  <a:pPr algn="ctr"/>
                  <a:r>
                    <a:rPr lang="en-US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_16730</a:t>
                  </a:r>
                </a:p>
              </p:txBody>
            </p:sp>
            <p:grpSp>
              <p:nvGrpSpPr>
                <p:cNvPr id="20" name="Groupe 19">
                  <a:extLst>
                    <a:ext uri="{FF2B5EF4-FFF2-40B4-BE49-F238E27FC236}">
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8DDC54D5-D007-CE44-8765-1C1FA0290CF8}"/>
                    </a:ext>
                  </a:extLst>
                </p:cNvPr>
                <p:cNvGrpSpPr/>
                <p:nvPr/>
              </p:nvGrpSpPr>
              <p:grpSpPr>
                <a:xfrm>
                  <a:off x="2745816" y="1585745"/>
                  <a:ext cx="395998" cy="314698"/>
                  <a:chOff x="2745816" y="1585745"/>
                  <a:chExt cx="395998" cy="314698"/>
                </a:xfrm>
              </p:grpSpPr>
              <p:sp>
                <p:nvSpPr>
                  <p:cNvPr id="173" name="TextBox 25">
                    <a:extLst>
                      <a:ext uri="{FF2B5EF4-FFF2-40B4-BE49-F238E27FC236}">
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D2E90C7E-5C29-BC4C-92DC-684B5E19E94F}"/>
                      </a:ext>
                    </a:extLst>
                  </p:cNvPr>
                  <p:cNvSpPr txBox="1"/>
                  <p:nvPr/>
                </p:nvSpPr>
                <p:spPr>
                  <a:xfrm>
                    <a:off x="2794173" y="1623444"/>
                    <a:ext cx="299285" cy="27699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</a:t>
                    </a:r>
                  </a:p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370)</a:t>
                    </a:r>
                  </a:p>
                </p:txBody>
              </p:sp>
              <p:cxnSp>
                <p:nvCxnSpPr>
                  <p:cNvPr id="174" name="Connecteur droit avec flèche 173">
                    <a:extLst>
                      <a:ext uri="{FF2B5EF4-FFF2-40B4-BE49-F238E27FC236}">
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EDE1A45C-EF39-DB46-9F28-9E394B0662A7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2745816" y="1585745"/>
                    <a:ext cx="395998" cy="0"/>
                  </a:xfrm>
                  <a:prstGeom prst="straightConnector1">
                    <a:avLst/>
                  </a:prstGeom>
                  <a:ln w="15875">
                    <a:solidFill>
                      <a:schemeClr val="tx1"/>
                    </a:solidFill>
                    <a:headEnd type="none"/>
                    <a:tailEnd type="none"/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8" name="Groupe 27">
                  <a:extLst>
                    <a:ext uri="{FF2B5EF4-FFF2-40B4-BE49-F238E27FC236}">
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090CF474-A410-FD42-99FD-981C36979532}"/>
                    </a:ext>
                  </a:extLst>
                </p:cNvPr>
                <p:cNvGrpSpPr/>
                <p:nvPr/>
              </p:nvGrpSpPr>
              <p:grpSpPr>
                <a:xfrm>
                  <a:off x="3109394" y="1372500"/>
                  <a:ext cx="395998" cy="319364"/>
                  <a:chOff x="3109394" y="1372500"/>
                  <a:chExt cx="395998" cy="319364"/>
                </a:xfrm>
              </p:grpSpPr>
              <p:cxnSp>
                <p:nvCxnSpPr>
                  <p:cNvPr id="175" name="Connecteur droit avec flèche 174">
                    <a:extLst>
                      <a:ext uri="{FF2B5EF4-FFF2-40B4-BE49-F238E27FC236}">
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6080DD54-E0F0-3E4B-AA42-D835F02ECD24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3109394" y="1372500"/>
                    <a:ext cx="395998" cy="0"/>
                  </a:xfrm>
                  <a:prstGeom prst="straightConnector1">
                    <a:avLst/>
                  </a:prstGeom>
                  <a:ln w="15875">
                    <a:solidFill>
                      <a:schemeClr val="tx1"/>
                    </a:solidFill>
                    <a:headEnd type="none"/>
                    <a:tailEnd type="none"/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76" name="TextBox 25">
                    <a:extLst>
                      <a:ext uri="{FF2B5EF4-FFF2-40B4-BE49-F238E27FC236}">
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4B656C72-FFDC-C345-9BF2-71ED8B4ACEDA}"/>
                      </a:ext>
                    </a:extLst>
                  </p:cNvPr>
                  <p:cNvSpPr txBox="1"/>
                  <p:nvPr/>
                </p:nvSpPr>
                <p:spPr>
                  <a:xfrm>
                    <a:off x="3157751" y="1414865"/>
                    <a:ext cx="299285" cy="27699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</a:t>
                    </a:r>
                  </a:p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381)</a:t>
                    </a:r>
                  </a:p>
                </p:txBody>
              </p:sp>
            </p:grpSp>
            <p:grpSp>
              <p:nvGrpSpPr>
                <p:cNvPr id="55" name="Groupe 54">
                  <a:extLst>
                    <a:ext uri="{FF2B5EF4-FFF2-40B4-BE49-F238E27FC236}">
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FE3D6480-992D-C441-B0A5-F0ED1A6EB345}"/>
                    </a:ext>
                  </a:extLst>
                </p:cNvPr>
                <p:cNvGrpSpPr/>
                <p:nvPr/>
              </p:nvGrpSpPr>
              <p:grpSpPr>
                <a:xfrm>
                  <a:off x="3577719" y="1372500"/>
                  <a:ext cx="431998" cy="300779"/>
                  <a:chOff x="3577719" y="1372500"/>
                  <a:chExt cx="431998" cy="300779"/>
                </a:xfrm>
              </p:grpSpPr>
              <p:cxnSp>
                <p:nvCxnSpPr>
                  <p:cNvPr id="177" name="Connecteur droit avec flèche 176">
                    <a:extLst>
                      <a:ext uri="{FF2B5EF4-FFF2-40B4-BE49-F238E27FC236}">
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36CBC2E7-0FDC-1147-893B-5E298C0E179E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3577719" y="1372500"/>
                    <a:ext cx="431998" cy="0"/>
                  </a:xfrm>
                  <a:prstGeom prst="straightConnector1">
                    <a:avLst/>
                  </a:prstGeom>
                  <a:ln w="15875">
                    <a:solidFill>
                      <a:schemeClr val="tx1"/>
                    </a:solidFill>
                    <a:headEnd type="none"/>
                    <a:tailEnd type="none"/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78" name="TextBox 25">
                    <a:extLst>
                      <a:ext uri="{FF2B5EF4-FFF2-40B4-BE49-F238E27FC236}">
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20222FB0-E029-344B-80F5-8A038C9FEBB5}"/>
                      </a:ext>
                    </a:extLst>
                  </p:cNvPr>
                  <p:cNvSpPr txBox="1"/>
                  <p:nvPr/>
                </p:nvSpPr>
                <p:spPr>
                  <a:xfrm>
                    <a:off x="3644076" y="1396280"/>
                    <a:ext cx="299285" cy="27699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</a:t>
                    </a:r>
                  </a:p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412)</a:t>
                    </a:r>
                  </a:p>
                </p:txBody>
              </p:sp>
            </p:grpSp>
            <p:grpSp>
              <p:nvGrpSpPr>
                <p:cNvPr id="63" name="Groupe 62">
                  <a:extLst>
                    <a:ext uri="{FF2B5EF4-FFF2-40B4-BE49-F238E27FC236}">
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CE608336-19BC-2949-A78D-89D9D2CCADE3}"/>
                    </a:ext>
                  </a:extLst>
                </p:cNvPr>
                <p:cNvGrpSpPr/>
                <p:nvPr/>
              </p:nvGrpSpPr>
              <p:grpSpPr>
                <a:xfrm>
                  <a:off x="3176730" y="528610"/>
                  <a:ext cx="657444" cy="576026"/>
                  <a:chOff x="3176730" y="528610"/>
                  <a:chExt cx="657444" cy="576026"/>
                </a:xfrm>
              </p:grpSpPr>
              <p:sp>
                <p:nvSpPr>
                  <p:cNvPr id="164" name="TextBox 119">
                    <a:extLst>
                      <a:ext uri="{FF2B5EF4-FFF2-40B4-BE49-F238E27FC236}">
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14494922-DB04-3C4E-995C-4937B2C8CF5A}"/>
                      </a:ext>
                    </a:extLst>
                  </p:cNvPr>
                  <p:cNvSpPr txBox="1"/>
                  <p:nvPr/>
                </p:nvSpPr>
                <p:spPr>
                  <a:xfrm>
                    <a:off x="3176730" y="735304"/>
                    <a:ext cx="657444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IMLP</a:t>
                    </a:r>
                  </a:p>
                  <a:p>
                    <a:pPr algn="ctr"/>
                    <a:r>
                      <a: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_16725</a:t>
                    </a:r>
                  </a:p>
                </p:txBody>
              </p:sp>
              <p:sp>
                <p:nvSpPr>
                  <p:cNvPr id="179" name="TextBox 120">
                    <a:extLst>
                      <a:ext uri="{FF2B5EF4-FFF2-40B4-BE49-F238E27FC236}">
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325C1CBD-40C1-2540-8E56-1EE5A3776880}"/>
                      </a:ext>
                    </a:extLst>
                  </p:cNvPr>
                  <p:cNvSpPr txBox="1"/>
                  <p:nvPr/>
                </p:nvSpPr>
                <p:spPr>
                  <a:xfrm>
                    <a:off x="3240254" y="528610"/>
                    <a:ext cx="530396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 fontAlgn="b"/>
                    <a:r>
                      <a:rPr lang="en-US" sz="1000" b="1" i="1" dirty="0" err="1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vicK</a:t>
                    </a:r>
                    <a:endParaRPr lang="en-US" sz="1000" b="1" i="1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</p:grpSp>
        <p:grpSp>
          <p:nvGrpSpPr>
            <p:cNvPr id="206" name="Groupe 205">
              <a:extLst>
                <a:ext uri="{FF2B5EF4-FFF2-40B4-BE49-F238E27FC236}">
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19929CD5-8028-D94A-8487-C4F4701EF65C}"/>
                </a:ext>
              </a:extLst>
            </p:cNvPr>
            <p:cNvGrpSpPr/>
            <p:nvPr/>
          </p:nvGrpSpPr>
          <p:grpSpPr>
            <a:xfrm>
              <a:off x="295960" y="2162046"/>
              <a:ext cx="6114249" cy="2787026"/>
              <a:chOff x="295960" y="2162046"/>
              <a:chExt cx="6114249" cy="2787026"/>
            </a:xfrm>
          </p:grpSpPr>
          <p:sp>
            <p:nvSpPr>
              <p:cNvPr id="146" name="ZoneTexte 145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12361157-DA3A-D24D-9FF5-ADEA66ABE0FE}"/>
                  </a:ext>
                </a:extLst>
              </p:cNvPr>
              <p:cNvSpPr txBox="1"/>
              <p:nvPr/>
            </p:nvSpPr>
            <p:spPr>
              <a:xfrm>
                <a:off x="295960" y="2162046"/>
                <a:ext cx="33214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grpSp>
            <p:nvGrpSpPr>
              <p:cNvPr id="205" name="Groupe 204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D58B2574-3701-0948-8701-ECD2DEB2DF2E}"/>
                  </a:ext>
                </a:extLst>
              </p:cNvPr>
              <p:cNvGrpSpPr/>
              <p:nvPr/>
            </p:nvGrpSpPr>
            <p:grpSpPr>
              <a:xfrm>
                <a:off x="441235" y="2524034"/>
                <a:ext cx="5968974" cy="2425038"/>
                <a:chOff x="441235" y="2524034"/>
                <a:chExt cx="5968974" cy="2425038"/>
              </a:xfrm>
            </p:grpSpPr>
            <p:grpSp>
              <p:nvGrpSpPr>
                <p:cNvPr id="137" name="Groupe 136">
                  <a:extLst>
                    <a:ext uri="{FF2B5EF4-FFF2-40B4-BE49-F238E27FC236}">
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14819442-5E8D-CF48-87C1-DB54E6617EC9}"/>
                    </a:ext>
                  </a:extLst>
                </p:cNvPr>
                <p:cNvGrpSpPr/>
                <p:nvPr/>
              </p:nvGrpSpPr>
              <p:grpSpPr>
                <a:xfrm>
                  <a:off x="441235" y="2524034"/>
                  <a:ext cx="1825195" cy="2425038"/>
                  <a:chOff x="64248" y="2524034"/>
                  <a:chExt cx="1825195" cy="2425038"/>
                </a:xfrm>
              </p:grpSpPr>
              <p:grpSp>
                <p:nvGrpSpPr>
                  <p:cNvPr id="70" name="Groupe 69">
                    <a:extLst>
                      <a:ext uri="{FF2B5EF4-FFF2-40B4-BE49-F238E27FC236}">
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8C9D7156-4C60-5B4A-9888-CFC67AE51E4F}"/>
                      </a:ext>
                    </a:extLst>
                  </p:cNvPr>
                  <p:cNvGrpSpPr/>
                  <p:nvPr/>
                </p:nvGrpSpPr>
                <p:grpSpPr>
                  <a:xfrm>
                    <a:off x="791209" y="2524034"/>
                    <a:ext cx="1098234" cy="627312"/>
                    <a:chOff x="791209" y="2524034"/>
                    <a:chExt cx="1098234" cy="627312"/>
                  </a:xfrm>
                </p:grpSpPr>
                <p:sp>
                  <p:nvSpPr>
                    <p:cNvPr id="34" name="TextBox 25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F51486AD-F5F1-B541-B930-0B0E0D82A2C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91209" y="2997458"/>
                      <a:ext cx="417823" cy="15388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1000" b="1" dirty="0" err="1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DNA</a:t>
                      </a:r>
                      <a:endParaRPr lang="en-US" sz="1000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" name="TextBox 25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ABCD1FF8-0532-9E43-8B79-399E895C32C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96443" y="2524034"/>
                      <a:ext cx="841715" cy="3693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1200" b="1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  <a:p>
                      <a:pPr algn="ctr"/>
                      <a:r>
                        <a:rPr lang="en-US" sz="1200" b="1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370 </a:t>
                      </a:r>
                      <a:r>
                        <a:rPr lang="en-US" sz="1200" b="1" dirty="0" err="1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p</a:t>
                      </a:r>
                      <a:r>
                        <a:rPr lang="en-US" sz="1200" b="1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p:txBody>
                </p:sp>
                <p:sp>
                  <p:nvSpPr>
                    <p:cNvPr id="36" name="TextBox 25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FC239F94-B5CE-764A-BD29-A8794A00BA2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196596" y="2997458"/>
                      <a:ext cx="391930" cy="15388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1000" b="1" dirty="0" err="1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NA</a:t>
                      </a:r>
                      <a:endParaRPr lang="en-US" sz="1000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7" name="TextBox 25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094CCD2A-DAB0-E148-AE68-3C1DCC2E123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590158" y="2997458"/>
                      <a:ext cx="299285" cy="15388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1000" b="1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NA</a:t>
                      </a:r>
                    </a:p>
                  </p:txBody>
                </p:sp>
                <p:sp>
                  <p:nvSpPr>
                    <p:cNvPr id="38" name="Parenthèse ouvrante 37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2DBADED8-0847-1143-AFE6-5C314E7FF29A}"/>
                        </a:ext>
                      </a:extLst>
                    </p:cNvPr>
                    <p:cNvSpPr/>
                    <p:nvPr/>
                  </p:nvSpPr>
                  <p:spPr>
                    <a:xfrm rot="5400000">
                      <a:off x="1316224" y="2429813"/>
                      <a:ext cx="45719" cy="1040561"/>
                    </a:xfrm>
                    <a:prstGeom prst="leftBracket">
                      <a:avLst/>
                    </a:prstGeom>
                    <a:ln w="1905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grpSp>
                <p:nvGrpSpPr>
                  <p:cNvPr id="66" name="Groupe 65">
                    <a:extLst>
                      <a:ext uri="{FF2B5EF4-FFF2-40B4-BE49-F238E27FC236}">
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A3D4F67A-1005-3E42-B971-D4F61922C38B}"/>
                      </a:ext>
                    </a:extLst>
                  </p:cNvPr>
                  <p:cNvGrpSpPr/>
                  <p:nvPr/>
                </p:nvGrpSpPr>
                <p:grpSpPr>
                  <a:xfrm>
                    <a:off x="64248" y="3946304"/>
                    <a:ext cx="487146" cy="728794"/>
                    <a:chOff x="64248" y="3946304"/>
                    <a:chExt cx="487146" cy="728794"/>
                  </a:xfrm>
                </p:grpSpPr>
                <p:grpSp>
                  <p:nvGrpSpPr>
                    <p:cNvPr id="104" name="Groupe 103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F13142A5-1EC6-A344-8972-7E772E8F50E2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93102" y="4344669"/>
                      <a:ext cx="439556" cy="215444"/>
                      <a:chOff x="10241" y="4178943"/>
                      <a:chExt cx="439556" cy="215444"/>
                    </a:xfrm>
                  </p:grpSpPr>
                  <p:cxnSp>
                    <p:nvCxnSpPr>
                      <p:cNvPr id="84" name="Connecteur droit avec flèche 83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FFB06D35-CD4A-174C-96AE-99F70D4F2F1D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341797" y="4284498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95" name="Rectangle 94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682545AF-F3B3-964F-95D3-07CCC6C9E47A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10241" y="4178943"/>
                        <a:ext cx="357790" cy="215444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800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600</a:t>
                        </a:r>
                        <a:endPara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grpSp>
                  <p:nvGrpSpPr>
                    <p:cNvPr id="105" name="Groupe 104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76F8AC73-B6FB-C84B-8196-40DC67524D14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93102" y="4210281"/>
                      <a:ext cx="439556" cy="215444"/>
                      <a:chOff x="10241" y="3831956"/>
                      <a:chExt cx="439556" cy="215444"/>
                    </a:xfrm>
                  </p:grpSpPr>
                  <p:cxnSp>
                    <p:nvCxnSpPr>
                      <p:cNvPr id="87" name="Connecteur droit avec flèche 86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47E62717-69F5-2741-AA90-0C8000D880FE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341797" y="3955403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96" name="Rectangle 95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7B729508-A379-9E4F-B47A-1BDA2AC3DF81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10241" y="3831956"/>
                        <a:ext cx="357790" cy="215444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800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800</a:t>
                        </a:r>
                        <a:endPara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grpSp>
                  <p:nvGrpSpPr>
                    <p:cNvPr id="107" name="Groupe 106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C49F01BC-6D2D-A645-91B5-371C1583CA1B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64248" y="4090604"/>
                      <a:ext cx="468410" cy="215444"/>
                      <a:chOff x="-18613" y="3542432"/>
                      <a:chExt cx="468410" cy="215444"/>
                    </a:xfrm>
                  </p:grpSpPr>
                  <p:sp>
                    <p:nvSpPr>
                      <p:cNvPr id="97" name="Rectangle 96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41A10FD5-51EA-D741-9209-43111B374349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-18613" y="3542432"/>
                        <a:ext cx="415498" cy="215444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800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000</a:t>
                        </a:r>
                        <a:endPara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grpSp>
                    <p:nvGrpSpPr>
                      <p:cNvPr id="106" name="Groupe 105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10EC03EF-A2A4-FD4F-A03F-EA8D841BDDC5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311886" y="3665448"/>
                        <a:ext cx="137911" cy="49020"/>
                        <a:chOff x="311886" y="3665448"/>
                        <a:chExt cx="137911" cy="49020"/>
                      </a:xfrm>
                    </p:grpSpPr>
                    <p:cxnSp>
                      <p:nvCxnSpPr>
                        <p:cNvPr id="88" name="Connecteur droit avec flèche 87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602FCE7C-2BA0-5D44-A50F-63B8C15D6AC1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>
                          <a:off x="341797" y="3711293"/>
                          <a:ext cx="108000" cy="0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headEnd type="none"/>
                          <a:tailEnd type="none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98" name="Connecteur droit avec flèche 97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140D480A-8B57-1249-921F-A2D1605FCFF7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 flipV="1">
                          <a:off x="311886" y="3665448"/>
                          <a:ext cx="36000" cy="49020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headEnd type="none"/>
                          <a:tailEnd type="none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</p:grpSp>
                <p:grpSp>
                  <p:nvGrpSpPr>
                    <p:cNvPr id="108" name="Groupe 107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4D4DEC2D-7B32-8846-A57E-325F33DA4840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64248" y="3946304"/>
                      <a:ext cx="468410" cy="215444"/>
                      <a:chOff x="-18613" y="3418391"/>
                      <a:chExt cx="468410" cy="215444"/>
                    </a:xfrm>
                  </p:grpSpPr>
                  <p:cxnSp>
                    <p:nvCxnSpPr>
                      <p:cNvPr id="89" name="Connecteur droit avec flèche 88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8182CF50-2AAC-0C44-8F96-7C53A9169A70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341797" y="3537628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00" name="Rectangle 99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58A6EFF0-1F32-6A4D-B22F-C0030D204134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-18613" y="3418391"/>
                        <a:ext cx="415498" cy="215444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800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500</a:t>
                        </a:r>
                        <a:endPara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cxnSp>
                  <p:nvCxnSpPr>
                    <p:cNvPr id="181" name="Connecteur droit avec flèche 180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ACF450DE-7CD0-0E42-B82C-59AC8490EB0A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443394" y="4575677"/>
                      <a:ext cx="108000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headEnd type="none"/>
                      <a:tailEnd type="none"/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82" name="Rectangle 181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5E7ABBA7-48DA-5743-9BA7-219235E57EF2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11838" y="4459654"/>
                      <a:ext cx="357790" cy="215444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sz="8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0</a:t>
                      </a:r>
                      <a:endParaRPr lang="fr-FR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pic>
                <p:nvPicPr>
                  <p:cNvPr id="65" name="Image 64">
                    <a:extLst>
                      <a:ext uri="{FF2B5EF4-FFF2-40B4-BE49-F238E27FC236}">
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F175BD36-C2C6-744E-A961-D0A1A7FE3777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"/>
                  <a:srcRect l="6131"/>
                  <a:stretch/>
                </p:blipFill>
                <p:spPr>
                  <a:xfrm>
                    <a:off x="531850" y="3200636"/>
                    <a:ext cx="1357593" cy="1748436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202" name="Groupe 201">
                  <a:extLst>
                    <a:ext uri="{FF2B5EF4-FFF2-40B4-BE49-F238E27FC236}">
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8B9DE5C5-F826-BA46-815C-7E9CC2CA6CCA}"/>
                    </a:ext>
                  </a:extLst>
                </p:cNvPr>
                <p:cNvGrpSpPr/>
                <p:nvPr/>
              </p:nvGrpSpPr>
              <p:grpSpPr>
                <a:xfrm>
                  <a:off x="2491920" y="2524034"/>
                  <a:ext cx="1851840" cy="2417017"/>
                  <a:chOff x="2302851" y="2524034"/>
                  <a:chExt cx="1851840" cy="2417017"/>
                </a:xfrm>
              </p:grpSpPr>
              <p:grpSp>
                <p:nvGrpSpPr>
                  <p:cNvPr id="99" name="Groupe 98">
                    <a:extLst>
                      <a:ext uri="{FF2B5EF4-FFF2-40B4-BE49-F238E27FC236}">
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CD13C8A9-B75C-F74D-B7C7-26FF515F8DFF}"/>
                      </a:ext>
                    </a:extLst>
                  </p:cNvPr>
                  <p:cNvGrpSpPr/>
                  <p:nvPr/>
                </p:nvGrpSpPr>
                <p:grpSpPr>
                  <a:xfrm>
                    <a:off x="2978629" y="2524034"/>
                    <a:ext cx="1152000" cy="627312"/>
                    <a:chOff x="2978629" y="2524034"/>
                    <a:chExt cx="1152000" cy="627312"/>
                  </a:xfrm>
                </p:grpSpPr>
                <p:sp>
                  <p:nvSpPr>
                    <p:cNvPr id="41" name="TextBox 25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1AC849BB-03DE-EA47-9DB6-3F02FCD2D3C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997143" y="2997458"/>
                      <a:ext cx="417823" cy="15388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1000" b="1" dirty="0" err="1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DNA</a:t>
                      </a:r>
                      <a:endParaRPr lang="en-US" sz="1000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2" name="TextBox 25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869567DD-DBCC-9D44-BF39-5516CD4C7B8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133771" y="2524034"/>
                      <a:ext cx="841715" cy="3693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1200" b="1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  <a:p>
                      <a:pPr algn="ctr"/>
                      <a:r>
                        <a:rPr lang="en-US" sz="1200" b="1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380 </a:t>
                      </a:r>
                      <a:r>
                        <a:rPr lang="en-US" sz="1200" b="1" dirty="0" err="1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p</a:t>
                      </a:r>
                      <a:r>
                        <a:rPr lang="en-US" sz="1200" b="1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p:txBody>
                </p:sp>
                <p:sp>
                  <p:nvSpPr>
                    <p:cNvPr id="43" name="TextBox 25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518B106F-2378-3B4B-BE65-373BA854460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380251" y="2997458"/>
                      <a:ext cx="391930" cy="15388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1000" b="1" dirty="0" err="1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NA</a:t>
                      </a:r>
                      <a:endParaRPr lang="en-US" sz="1000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4" name="TextBox 25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70B8109B-A44C-9E4E-BEA3-F24B3E6F10C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784510" y="2997458"/>
                      <a:ext cx="299285" cy="15388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1000" b="1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NA</a:t>
                      </a:r>
                    </a:p>
                  </p:txBody>
                </p:sp>
                <p:sp>
                  <p:nvSpPr>
                    <p:cNvPr id="45" name="Parenthèse ouvrante 44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CE9A4B21-80B9-704D-B380-8F3B5B969263}"/>
                        </a:ext>
                      </a:extLst>
                    </p:cNvPr>
                    <p:cNvSpPr/>
                    <p:nvPr/>
                  </p:nvSpPr>
                  <p:spPr>
                    <a:xfrm rot="5400000">
                      <a:off x="3531769" y="2374093"/>
                      <a:ext cx="45719" cy="1152000"/>
                    </a:xfrm>
                    <a:prstGeom prst="leftBracket">
                      <a:avLst/>
                    </a:prstGeom>
                    <a:ln w="1905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grpSp>
                <p:nvGrpSpPr>
                  <p:cNvPr id="184" name="Groupe 183">
                    <a:extLst>
                      <a:ext uri="{FF2B5EF4-FFF2-40B4-BE49-F238E27FC236}">
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E9A9FFD9-D460-CE4B-8B4E-9D5B88591641}"/>
                      </a:ext>
                    </a:extLst>
                  </p:cNvPr>
                  <p:cNvGrpSpPr/>
                  <p:nvPr/>
                </p:nvGrpSpPr>
                <p:grpSpPr>
                  <a:xfrm>
                    <a:off x="2302851" y="4074466"/>
                    <a:ext cx="487146" cy="849109"/>
                    <a:chOff x="64248" y="3946304"/>
                    <a:chExt cx="487146" cy="849109"/>
                  </a:xfrm>
                </p:grpSpPr>
                <p:grpSp>
                  <p:nvGrpSpPr>
                    <p:cNvPr id="185" name="Groupe 184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76059042-6BF2-194C-9D06-329D5D931F41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93102" y="4416858"/>
                      <a:ext cx="439556" cy="215444"/>
                      <a:chOff x="10241" y="4251132"/>
                      <a:chExt cx="439556" cy="215444"/>
                    </a:xfrm>
                  </p:grpSpPr>
                  <p:cxnSp>
                    <p:nvCxnSpPr>
                      <p:cNvPr id="199" name="Connecteur droit avec flèche 198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512E1083-1C55-E740-AFCC-7D857C9C04A9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341797" y="4356687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200" name="Rectangle 199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17D60EF3-1361-014C-A9F9-F6989DCCE357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10241" y="4251132"/>
                        <a:ext cx="357790" cy="215444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800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600</a:t>
                        </a:r>
                        <a:endPara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grpSp>
                  <p:nvGrpSpPr>
                    <p:cNvPr id="186" name="Groupe 185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B5FB94C3-3BC7-184E-B3BF-BBA4B78AF5A1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93102" y="4282470"/>
                      <a:ext cx="439556" cy="215444"/>
                      <a:chOff x="10241" y="3904145"/>
                      <a:chExt cx="439556" cy="215444"/>
                    </a:xfrm>
                  </p:grpSpPr>
                  <p:cxnSp>
                    <p:nvCxnSpPr>
                      <p:cNvPr id="197" name="Connecteur droit avec flèche 196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857C5F37-C69A-AC4E-A7E6-D975E79407C4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341797" y="4027592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98" name="Rectangle 197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267661EE-AB2A-514D-909D-E6C8A700D50F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10241" y="3904145"/>
                        <a:ext cx="357790" cy="215444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800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800</a:t>
                        </a:r>
                        <a:endPara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grpSp>
                  <p:nvGrpSpPr>
                    <p:cNvPr id="187" name="Groupe 186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EEF7338E-7CD0-0A42-903C-48A6C305D530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64248" y="4114667"/>
                      <a:ext cx="468410" cy="215444"/>
                      <a:chOff x="-18613" y="3566495"/>
                      <a:chExt cx="468410" cy="215444"/>
                    </a:xfrm>
                  </p:grpSpPr>
                  <p:sp>
                    <p:nvSpPr>
                      <p:cNvPr id="193" name="Rectangle 192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55281A14-ED87-AE4A-A560-B58E5B300AAA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-18613" y="3566495"/>
                        <a:ext cx="415498" cy="215444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800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000</a:t>
                        </a:r>
                        <a:endPara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grpSp>
                    <p:nvGrpSpPr>
                      <p:cNvPr id="194" name="Groupe 193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ED8F9599-1A48-CD49-9A85-CDEAC006100F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311886" y="3689511"/>
                        <a:ext cx="137911" cy="49020"/>
                        <a:chOff x="311886" y="3689511"/>
                        <a:chExt cx="137911" cy="49020"/>
                      </a:xfrm>
                    </p:grpSpPr>
                    <p:cxnSp>
                      <p:nvCxnSpPr>
                        <p:cNvPr id="195" name="Connecteur droit avec flèche 194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E6FD2C13-9E47-0341-BCA0-65D3F685A113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>
                          <a:off x="341797" y="3735356"/>
                          <a:ext cx="108000" cy="0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headEnd type="none"/>
                          <a:tailEnd type="none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196" name="Connecteur droit avec flèche 195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C1D03965-3BE4-0945-B9A9-BF094DB6DF4E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 flipV="1">
                          <a:off x="311886" y="3689511"/>
                          <a:ext cx="36000" cy="49020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headEnd type="none"/>
                          <a:tailEnd type="none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</p:grpSp>
                <p:grpSp>
                  <p:nvGrpSpPr>
                    <p:cNvPr id="188" name="Groupe 187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A485D1CB-3776-BA45-9456-AAB3BFD83663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64248" y="3946304"/>
                      <a:ext cx="468410" cy="215444"/>
                      <a:chOff x="-18613" y="3418391"/>
                      <a:chExt cx="468410" cy="215444"/>
                    </a:xfrm>
                  </p:grpSpPr>
                  <p:cxnSp>
                    <p:nvCxnSpPr>
                      <p:cNvPr id="191" name="Connecteur droit avec flèche 190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4729AE60-DCBA-754B-8506-87977978863C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341797" y="3537628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92" name="Rectangle 191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7211CCE4-2712-6B46-9B3A-29A07920A657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-18613" y="3418391"/>
                        <a:ext cx="415498" cy="215444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800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500</a:t>
                        </a:r>
                        <a:endPara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cxnSp>
                  <p:nvCxnSpPr>
                    <p:cNvPr id="189" name="Connecteur droit avec flèche 188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D9586874-B7EC-A045-9842-80D58E3691A2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443394" y="4695992"/>
                      <a:ext cx="108000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headEnd type="none"/>
                      <a:tailEnd type="none"/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90" name="Rectangle 189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DB1D1505-40B9-584C-956C-39A0F4DC7A76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11838" y="4579969"/>
                      <a:ext cx="357790" cy="215444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sz="8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0</a:t>
                      </a:r>
                      <a:endParaRPr lang="fr-FR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pic>
                <p:nvPicPr>
                  <p:cNvPr id="183" name="Image 182">
                    <a:extLst>
                      <a:ext uri="{FF2B5EF4-FFF2-40B4-BE49-F238E27FC236}">
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5B75F795-F455-5448-80D1-E6D7E1AFDF31}"/>
                      </a:ext>
                    </a:extLst>
                  </p:cNvPr>
                  <p:cNvPicPr preferRelativeResize="0">
                    <a:picLocks/>
                  </p:cNvPicPr>
                  <p:nvPr/>
                </p:nvPicPr>
                <p:blipFill>
                  <a:blip r:embed="rId3"/>
                  <a:stretch>
                    <a:fillRect/>
                  </a:stretch>
                </p:blipFill>
                <p:spPr>
                  <a:xfrm>
                    <a:off x="2753136" y="3191451"/>
                    <a:ext cx="1401555" cy="1749600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203" name="Groupe 202">
                  <a:extLst>
                    <a:ext uri="{FF2B5EF4-FFF2-40B4-BE49-F238E27FC236}">
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DE559BD4-D5D6-6D4B-9A5F-156374652E9A}"/>
                    </a:ext>
                  </a:extLst>
                </p:cNvPr>
                <p:cNvGrpSpPr/>
                <p:nvPr/>
              </p:nvGrpSpPr>
              <p:grpSpPr>
                <a:xfrm>
                  <a:off x="4505082" y="2524034"/>
                  <a:ext cx="1905127" cy="2425038"/>
                  <a:chOff x="4400809" y="2524034"/>
                  <a:chExt cx="1905127" cy="2425038"/>
                </a:xfrm>
              </p:grpSpPr>
              <p:grpSp>
                <p:nvGrpSpPr>
                  <p:cNvPr id="134" name="Groupe 133">
                    <a:extLst>
                      <a:ext uri="{FF2B5EF4-FFF2-40B4-BE49-F238E27FC236}">
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70C03B0B-39FE-AE47-9296-A6C5505913F3}"/>
                      </a:ext>
                    </a:extLst>
                  </p:cNvPr>
                  <p:cNvGrpSpPr/>
                  <p:nvPr/>
                </p:nvGrpSpPr>
                <p:grpSpPr>
                  <a:xfrm>
                    <a:off x="5153936" y="2524034"/>
                    <a:ext cx="1152000" cy="627312"/>
                    <a:chOff x="5153936" y="2524034"/>
                    <a:chExt cx="1152000" cy="627312"/>
                  </a:xfrm>
                </p:grpSpPr>
                <p:sp>
                  <p:nvSpPr>
                    <p:cNvPr id="47" name="TextBox 25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F737525C-2F31-5D45-9A91-F66D5FCBFC8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309078" y="2524034"/>
                      <a:ext cx="841715" cy="3693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1200" b="1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  <a:p>
                      <a:pPr algn="ctr"/>
                      <a:r>
                        <a:rPr lang="en-US" sz="1200" b="1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412 </a:t>
                      </a:r>
                      <a:r>
                        <a:rPr lang="en-US" sz="1200" b="1" dirty="0" err="1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p</a:t>
                      </a:r>
                      <a:r>
                        <a:rPr lang="en-US" sz="1200" b="1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p:txBody>
                </p:sp>
                <p:sp>
                  <p:nvSpPr>
                    <p:cNvPr id="48" name="TextBox 25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3C8A8474-7FA6-BA43-BEEE-CE406B51F35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578995" y="2997458"/>
                      <a:ext cx="391930" cy="15388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1000" b="1" dirty="0" err="1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NA</a:t>
                      </a:r>
                      <a:endParaRPr lang="en-US" sz="1000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9" name="Parenthèse ouvrante 48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39A2672C-2398-8548-849D-353617270798}"/>
                        </a:ext>
                      </a:extLst>
                    </p:cNvPr>
                    <p:cNvSpPr/>
                    <p:nvPr/>
                  </p:nvSpPr>
                  <p:spPr>
                    <a:xfrm rot="5400000">
                      <a:off x="5707076" y="2374093"/>
                      <a:ext cx="45719" cy="1152000"/>
                    </a:xfrm>
                    <a:prstGeom prst="leftBracket">
                      <a:avLst/>
                    </a:prstGeom>
                    <a:ln w="1905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0" name="TextBox 25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7914316E-8A81-BB47-811A-6ECC27035E7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185235" y="2997458"/>
                      <a:ext cx="417823" cy="15388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1000" b="1" dirty="0" err="1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DNA</a:t>
                      </a:r>
                      <a:endParaRPr lang="en-US" sz="1000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1" name="TextBox 25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D23E93E6-716B-2E46-BF8A-0663FF0F543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979731" y="2997458"/>
                      <a:ext cx="299285" cy="15388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1000" b="1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NA</a:t>
                      </a:r>
                    </a:p>
                  </p:txBody>
                </p:sp>
              </p:grpSp>
              <p:grpSp>
                <p:nvGrpSpPr>
                  <p:cNvPr id="69" name="Groupe 68">
                    <a:extLst>
                      <a:ext uri="{FF2B5EF4-FFF2-40B4-BE49-F238E27FC236}">
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3A52131D-E81B-BD43-8058-5D5247EDE7EB}"/>
                      </a:ext>
                    </a:extLst>
                  </p:cNvPr>
                  <p:cNvGrpSpPr/>
                  <p:nvPr/>
                </p:nvGrpSpPr>
                <p:grpSpPr>
                  <a:xfrm>
                    <a:off x="4400809" y="3916015"/>
                    <a:ext cx="468410" cy="814358"/>
                    <a:chOff x="5083520" y="3417864"/>
                    <a:chExt cx="468410" cy="814358"/>
                  </a:xfrm>
                </p:grpSpPr>
                <p:sp>
                  <p:nvSpPr>
                    <p:cNvPr id="121" name="Rectangle 120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428D145F-9393-904D-BDF7-A0AFEB0E6500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5083520" y="3541905"/>
                      <a:ext cx="415498" cy="215444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sz="8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0</a:t>
                      </a:r>
                      <a:endParaRPr lang="fr-FR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grpSp>
                  <p:nvGrpSpPr>
                    <p:cNvPr id="122" name="Groupe 121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EF06DE6C-CD16-124F-8B85-53FD0D997695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5412102" y="3662475"/>
                      <a:ext cx="139828" cy="49020"/>
                      <a:chOff x="309969" y="3663002"/>
                      <a:chExt cx="139828" cy="49020"/>
                    </a:xfrm>
                  </p:grpSpPr>
                  <p:cxnSp>
                    <p:nvCxnSpPr>
                      <p:cNvPr id="123" name="Connecteur droit avec flèche 122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AE34598E-AD18-294A-BE63-9F614524CEE3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341797" y="3711293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24" name="Connecteur droit avec flèche 123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7FA763B3-2D9A-7F47-820E-A6D43A0FEDC7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 flipV="1">
                        <a:off x="309969" y="3663002"/>
                        <a:ext cx="36000" cy="4902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cxnSp>
                  <p:nvCxnSpPr>
                    <p:cNvPr id="126" name="Connecteur droit avec flèche 125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A8C5E694-06B4-1747-84B1-99C2D1025953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5443930" y="3537101"/>
                      <a:ext cx="108000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headEnd type="none"/>
                      <a:tailEnd type="none"/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27" name="Rectangle 126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8BA6ED3B-F199-E548-9BB4-29A05DE8F088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5083520" y="3417864"/>
                      <a:ext cx="415498" cy="215444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sz="8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00</a:t>
                      </a:r>
                      <a:endParaRPr lang="fr-FR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cxnSp>
                  <p:nvCxnSpPr>
                    <p:cNvPr id="112" name="Connecteur droit avec flèche 111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34B0C16E-7815-AA41-A3D3-9B046BB1126D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5439983" y="4132801"/>
                      <a:ext cx="108000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headEnd type="none"/>
                      <a:tailEnd type="none"/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13" name="Rectangle 112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4578775C-B4FA-F542-88F5-0A4ACA9DEF99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5108427" y="4016778"/>
                      <a:ext cx="357790" cy="215444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sz="8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0</a:t>
                      </a:r>
                      <a:endParaRPr lang="fr-FR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grpSp>
                  <p:nvGrpSpPr>
                    <p:cNvPr id="114" name="Groupe 113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86F721F6-862C-2843-B659-FA40C46A0320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5108427" y="3899839"/>
                      <a:ext cx="439556" cy="215444"/>
                      <a:chOff x="10241" y="3811296"/>
                      <a:chExt cx="439556" cy="215444"/>
                    </a:xfrm>
                  </p:grpSpPr>
                  <p:cxnSp>
                    <p:nvCxnSpPr>
                      <p:cNvPr id="115" name="Connecteur droit avec flèche 114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0EFD55DF-0750-254C-BF98-120169DA656A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341797" y="3916851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16" name="Rectangle 115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6E2FBB57-C3B7-CB4C-996E-C46B007815C8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10241" y="3811296"/>
                        <a:ext cx="357790" cy="215444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800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600</a:t>
                        </a:r>
                        <a:endPara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grpSp>
                  <p:nvGrpSpPr>
                    <p:cNvPr id="117" name="Groupe 116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D82A3C84-5BD8-8B42-AFDB-3B33315E859E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5108427" y="3782900"/>
                      <a:ext cx="439556" cy="215444"/>
                      <a:chOff x="10241" y="3662273"/>
                      <a:chExt cx="439556" cy="215444"/>
                    </a:xfrm>
                  </p:grpSpPr>
                  <p:cxnSp>
                    <p:nvCxnSpPr>
                      <p:cNvPr id="118" name="Connecteur droit avec flèche 117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2A42EF93-486F-EA40-A878-163196815111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341797" y="3785720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19" name="Rectangle 118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739E2807-EB49-8E4E-A17D-424D141F374F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10241" y="3662273"/>
                        <a:ext cx="357790" cy="215444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800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800</a:t>
                        </a:r>
                        <a:endPara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</p:grpSp>
              <p:pic>
                <p:nvPicPr>
                  <p:cNvPr id="201" name="Image 200">
                    <a:extLst>
                      <a:ext uri="{FF2B5EF4-FFF2-40B4-BE49-F238E27FC236}">
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0151A834-EBB9-4440-85F2-F50BD68C5019}"/>
                      </a:ext>
                    </a:extLst>
                  </p:cNvPr>
                  <p:cNvPicPr preferRelativeResize="0">
                    <a:picLocks/>
                  </p:cNvPicPr>
                  <p:nvPr/>
                </p:nvPicPr>
                <p:blipFill>
                  <a:blip r:embed="rId4"/>
                  <a:stretch>
                    <a:fillRect/>
                  </a:stretch>
                </p:blipFill>
                <p:spPr>
                  <a:xfrm>
                    <a:off x="4866120" y="3199472"/>
                    <a:ext cx="1439815" cy="1749600"/>
                  </a:xfrm>
                  <a:prstGeom prst="rect">
                    <a:avLst/>
                  </a:prstGeom>
                </p:spPr>
              </p:pic>
            </p:grpSp>
          </p:grpSp>
        </p:grpSp>
        <p:sp>
          <p:nvSpPr>
            <p:cNvPr id="109" name="TextBox 104">
              <a:extLst>
                <a:ext uri="{FF2B5EF4-FFF2-40B4-BE49-F238E27FC236}">
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E77773B0-F366-CC4B-AD24-DDE203467850}"/>
                </a:ext>
              </a:extLst>
            </p:cNvPr>
            <p:cNvSpPr txBox="1"/>
            <p:nvPr/>
          </p:nvSpPr>
          <p:spPr>
            <a:xfrm>
              <a:off x="657559" y="5648417"/>
              <a:ext cx="427093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2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8 Fig. 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Operon organization of </a:t>
              </a:r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erR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-controlled </a:t>
              </a:r>
              <a:r>
                <a:rPr lang="en-US" sz="12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vicKR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  <a:endParaRPr lang="fr-F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37534219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:a="http://schemas.openxmlformats.org/drawingml/2006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5</TotalTime>
  <Words>76</Words>
  <Application>Microsoft Macintosh PowerPoint</Application>
  <PresentationFormat>Présentation à l'écran (4:3)</PresentationFormat>
  <Paragraphs>51</Paragraphs>
  <Slides>1</Slides>
  <Notes>0</Notes>
  <HiddenSlides>0</HiddenSlides>
  <MMClips>0</MMClips>
  <ScaleCrop>false</ScaleCrop>
  <HeadingPairs>
    <vt:vector size="4" baseType="variant">
      <vt:variant>
        <vt:lpstr>Modèle de conception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icrosoft Office User</dc:creator>
  <cp:lastModifiedBy>nadia benaroudj</cp:lastModifiedBy>
  <cp:revision>16</cp:revision>
  <cp:lastPrinted>2020-03-17T21:01:28Z</cp:lastPrinted>
  <dcterms:created xsi:type="dcterms:W3CDTF">2020-04-03T13:34:24Z</dcterms:created>
  <dcterms:modified xsi:type="dcterms:W3CDTF">2020-04-03T13:47:31Z</dcterms:modified>
</cp:coreProperties>
</file>